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5.png" ContentType="image/png"/>
  <Override PartName="/ppt/media/image9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3.wmf" ContentType="image/x-wmf"/>
  <Override PartName="/ppt/media/image6.png" ContentType="image/png"/>
  <Override PartName="/ppt/media/image11.png" ContentType="image/png"/>
  <Override PartName="/ppt/media/image10.wmf" ContentType="image/x-wmf"/>
  <Override PartName="/ppt/media/image2.png" ContentType="image/png"/>
  <Override PartName="/ppt/media/image7.wmf" ContentType="image/x-wmf"/>
  <Override PartName="/ppt/media/image4.png" ContentType="image/png"/>
  <Override PartName="/ppt/media/image12.wmf" ContentType="image/x-wmf"/>
  <Override PartName="/ppt/media/image8.png" ContentType="image/png"/>
  <Override PartName="/ppt/media/image16.wmf" ContentType="image/x-wm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29077-6AEA-4C00-B87C-0836282649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6FBF7-DF21-4591-8C49-CA94D7FE4A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A43F7-8C76-4FE4-B68C-5B7B6F2D5A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8307C-BC32-4E3C-8B2D-9F922E1290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220D7-59FE-4C85-93EB-F81032E259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2DAB6-5227-4831-97EC-152DF37A21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478D3-ED4C-4A96-AEDA-E24D9AD476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EDEA7-554B-451E-839B-1EDB8D31C3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22F9F1-0662-4FB5-BE0B-4BEAF3D776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F49FA-6BE3-46BA-8DB1-C46871821C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17FA3-9B5F-4056-B3CC-0D018F390B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533A0-B76D-43D2-9B39-4E97154F63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DCE293-3591-4CF3-9BF8-A0D93A1873B9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1"/>
          <p:cNvSpPr/>
          <p:nvPr/>
        </p:nvSpPr>
        <p:spPr>
          <a:xfrm>
            <a:off x="423720" y="1982880"/>
            <a:ext cx="1137132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</a:t>
            </a:r>
            <a:endParaRPr b="0" lang="en-US" sz="3200" spc="-1" strike="noStrike">
              <a:solidFill>
                <a:srgbClr val="000000"/>
              </a:solidFill>
              <a:latin typeface="等线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等线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atistically significant KEGG signaling pathways involved in differentially expressed genes between invasive and non-invasive NFPAs</a:t>
            </a:r>
            <a:endParaRPr b="0" lang="en-US" sz="24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文本框 1"/>
          <p:cNvSpPr/>
          <p:nvPr/>
        </p:nvSpPr>
        <p:spPr>
          <a:xfrm>
            <a:off x="853920" y="357120"/>
            <a:ext cx="383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8. T cell receptor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8" name="图片 3" descr=""/>
          <p:cNvPicPr/>
          <p:nvPr/>
        </p:nvPicPr>
        <p:blipFill>
          <a:blip r:embed="rId1"/>
          <a:srcRect l="255" t="7247" r="965" b="4202"/>
          <a:stretch/>
        </p:blipFill>
        <p:spPr>
          <a:xfrm>
            <a:off x="2374920" y="714240"/>
            <a:ext cx="7678800" cy="5962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本框 1"/>
          <p:cNvSpPr/>
          <p:nvPr/>
        </p:nvSpPr>
        <p:spPr>
          <a:xfrm>
            <a:off x="893880" y="506520"/>
            <a:ext cx="30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. VEGF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0" name="图片 3" descr=""/>
          <p:cNvPicPr/>
          <p:nvPr/>
        </p:nvPicPr>
        <p:blipFill>
          <a:blip r:embed="rId1"/>
          <a:srcRect l="3252" t="13163" r="2178" b="4419"/>
          <a:stretch/>
        </p:blipFill>
        <p:spPr>
          <a:xfrm>
            <a:off x="933480" y="893880"/>
            <a:ext cx="10829880" cy="5732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文本框 1"/>
          <p:cNvSpPr/>
          <p:nvPr/>
        </p:nvSpPr>
        <p:spPr>
          <a:xfrm>
            <a:off x="692280" y="237960"/>
            <a:ext cx="377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. Arachidonic acid metabolis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2" name="图片 6" descr=""/>
          <p:cNvPicPr/>
          <p:nvPr/>
        </p:nvPicPr>
        <p:blipFill>
          <a:blip r:embed="rId1"/>
          <a:stretch/>
        </p:blipFill>
        <p:spPr>
          <a:xfrm>
            <a:off x="415800" y="743040"/>
            <a:ext cx="11430000" cy="564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1"/>
          <p:cNvSpPr/>
          <p:nvPr/>
        </p:nvSpPr>
        <p:spPr>
          <a:xfrm>
            <a:off x="484200" y="169920"/>
            <a:ext cx="376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1. Dopaminergic synaps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4" name="图片 3" descr=""/>
          <p:cNvPicPr/>
          <p:nvPr/>
        </p:nvPicPr>
        <p:blipFill>
          <a:blip r:embed="rId1"/>
          <a:srcRect l="1368" t="8983" r="1368" b="3333"/>
          <a:stretch/>
        </p:blipFill>
        <p:spPr>
          <a:xfrm>
            <a:off x="385920" y="557280"/>
            <a:ext cx="11585520" cy="6153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文本框 1"/>
          <p:cNvSpPr/>
          <p:nvPr/>
        </p:nvSpPr>
        <p:spPr>
          <a:xfrm>
            <a:off x="584280" y="204840"/>
            <a:ext cx="32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2. MAPK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6" name="图片 6" descr=""/>
          <p:cNvPicPr/>
          <p:nvPr/>
        </p:nvPicPr>
        <p:blipFill>
          <a:blip r:embed="rId1"/>
          <a:stretch/>
        </p:blipFill>
        <p:spPr>
          <a:xfrm>
            <a:off x="789120" y="614520"/>
            <a:ext cx="10490040" cy="6002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文本框 1"/>
          <p:cNvSpPr/>
          <p:nvPr/>
        </p:nvSpPr>
        <p:spPr>
          <a:xfrm>
            <a:off x="804960" y="298440"/>
            <a:ext cx="264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3. Viral carcinogenesi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8" name="图片 6" descr=""/>
          <p:cNvPicPr/>
          <p:nvPr/>
        </p:nvPicPr>
        <p:blipFill>
          <a:blip r:embed="rId1"/>
          <a:stretch/>
        </p:blipFill>
        <p:spPr>
          <a:xfrm>
            <a:off x="322200" y="700200"/>
            <a:ext cx="11420640" cy="5986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文本框 1"/>
          <p:cNvSpPr/>
          <p:nvPr/>
        </p:nvSpPr>
        <p:spPr>
          <a:xfrm>
            <a:off x="469800" y="171360"/>
            <a:ext cx="2146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4. Focal adhes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0" name="图片 3" descr=""/>
          <p:cNvPicPr/>
          <p:nvPr/>
        </p:nvPicPr>
        <p:blipFill>
          <a:blip r:embed="rId1"/>
          <a:srcRect l="1483" t="11040" r="1633" b="3769"/>
          <a:stretch/>
        </p:blipFill>
        <p:spPr>
          <a:xfrm>
            <a:off x="270000" y="569880"/>
            <a:ext cx="11540880" cy="6175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文本框 1"/>
          <p:cNvSpPr/>
          <p:nvPr/>
        </p:nvSpPr>
        <p:spPr>
          <a:xfrm>
            <a:off x="353880" y="144360"/>
            <a:ext cx="306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5. ErbB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2" name="图片 3" descr=""/>
          <p:cNvPicPr/>
          <p:nvPr/>
        </p:nvPicPr>
        <p:blipFill>
          <a:blip r:embed="rId1"/>
          <a:srcRect l="2007" t="9254" r="1126" b="4083"/>
          <a:stretch/>
        </p:blipFill>
        <p:spPr>
          <a:xfrm>
            <a:off x="409680" y="546120"/>
            <a:ext cx="11263320" cy="6122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文本框 3"/>
          <p:cNvSpPr/>
          <p:nvPr/>
        </p:nvSpPr>
        <p:spPr>
          <a:xfrm>
            <a:off x="444600" y="142920"/>
            <a:ext cx="300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6. Amphetamine addi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4" name="图片 8" descr=""/>
          <p:cNvPicPr/>
          <p:nvPr/>
        </p:nvPicPr>
        <p:blipFill>
          <a:blip r:embed="rId1"/>
          <a:stretch/>
        </p:blipFill>
        <p:spPr>
          <a:xfrm>
            <a:off x="2071800" y="511200"/>
            <a:ext cx="8048520" cy="6200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文本框 5"/>
          <p:cNvSpPr/>
          <p:nvPr/>
        </p:nvSpPr>
        <p:spPr>
          <a:xfrm>
            <a:off x="1866960" y="1031760"/>
            <a:ext cx="5894280" cy="47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 Rap1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. Gap jun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. Phagosom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. Pathogenic Escherichia coli infe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. GnRH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6. Inflammatory mediator regulation of TRP channel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7. Retrograde endocannabinoid signaling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8. T cell receptor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. VEGF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. Arachidonic acid metabolism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1. Dopaminergic synaps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2. MAPK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3. Viral carcinogenesi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4. Focal adhes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5. ErbB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6. Amphetamine addi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1"/>
          <p:cNvSpPr/>
          <p:nvPr/>
        </p:nvSpPr>
        <p:spPr>
          <a:xfrm>
            <a:off x="963720" y="517680"/>
            <a:ext cx="309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 Rap1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4" name="图片 3" descr=""/>
          <p:cNvPicPr/>
          <p:nvPr/>
        </p:nvPicPr>
        <p:blipFill>
          <a:blip r:embed="rId1"/>
          <a:srcRect l="4303" t="8984" r="1181" b="4494"/>
          <a:stretch/>
        </p:blipFill>
        <p:spPr>
          <a:xfrm>
            <a:off x="1405080" y="1015920"/>
            <a:ext cx="9326520" cy="5686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1"/>
          <p:cNvSpPr/>
          <p:nvPr/>
        </p:nvSpPr>
        <p:spPr>
          <a:xfrm>
            <a:off x="828720" y="268200"/>
            <a:ext cx="181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. Gap jun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6" name="图片 3" descr=""/>
          <p:cNvPicPr/>
          <p:nvPr/>
        </p:nvPicPr>
        <p:blipFill>
          <a:blip r:embed="rId1"/>
          <a:srcRect l="1848" t="9300" r="1101" b="3766"/>
          <a:stretch/>
        </p:blipFill>
        <p:spPr>
          <a:xfrm>
            <a:off x="2646360" y="638280"/>
            <a:ext cx="6899400" cy="5960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1"/>
          <p:cNvSpPr/>
          <p:nvPr/>
        </p:nvSpPr>
        <p:spPr>
          <a:xfrm>
            <a:off x="765000" y="338040"/>
            <a:ext cx="174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. Phagosome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8" name="图片 6" descr=""/>
          <p:cNvPicPr/>
          <p:nvPr/>
        </p:nvPicPr>
        <p:blipFill>
          <a:blip r:embed="rId1"/>
          <a:stretch/>
        </p:blipFill>
        <p:spPr>
          <a:xfrm>
            <a:off x="1504800" y="722160"/>
            <a:ext cx="8753760" cy="5932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1"/>
          <p:cNvSpPr/>
          <p:nvPr/>
        </p:nvSpPr>
        <p:spPr>
          <a:xfrm>
            <a:off x="814320" y="225360"/>
            <a:ext cx="434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. Pathogenic Escherichia coli infection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0" name="图片 3" descr=""/>
          <p:cNvPicPr/>
          <p:nvPr/>
        </p:nvPicPr>
        <p:blipFill>
          <a:blip r:embed="rId1"/>
          <a:srcRect l="1272" t="7851" r="450" b="2967"/>
          <a:stretch/>
        </p:blipFill>
        <p:spPr>
          <a:xfrm>
            <a:off x="2335320" y="660240"/>
            <a:ext cx="7456320" cy="5972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1"/>
          <p:cNvSpPr/>
          <p:nvPr/>
        </p:nvSpPr>
        <p:spPr>
          <a:xfrm>
            <a:off x="725400" y="298440"/>
            <a:ext cx="29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. GnRH signaling pathway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2" name="图片 3" descr=""/>
          <p:cNvPicPr/>
          <p:nvPr/>
        </p:nvPicPr>
        <p:blipFill>
          <a:blip r:embed="rId1"/>
          <a:srcRect l="3329" t="9560" r="1378" b="4889"/>
          <a:stretch/>
        </p:blipFill>
        <p:spPr>
          <a:xfrm>
            <a:off x="565200" y="725400"/>
            <a:ext cx="11271240" cy="5711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文本框 1"/>
          <p:cNvSpPr/>
          <p:nvPr/>
        </p:nvSpPr>
        <p:spPr>
          <a:xfrm>
            <a:off x="884160" y="378000"/>
            <a:ext cx="5645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6. Inflammatory mediator regulation of TRP channels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4" name="图片 3" descr=""/>
          <p:cNvPicPr/>
          <p:nvPr/>
        </p:nvPicPr>
        <p:blipFill>
          <a:blip r:embed="rId1"/>
          <a:srcRect l="2036" t="6955" r="544" b="3188"/>
          <a:stretch/>
        </p:blipFill>
        <p:spPr>
          <a:xfrm>
            <a:off x="836640" y="782640"/>
            <a:ext cx="10158480" cy="591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文本框 1"/>
          <p:cNvSpPr/>
          <p:nvPr/>
        </p:nvSpPr>
        <p:spPr>
          <a:xfrm>
            <a:off x="1112760" y="496800"/>
            <a:ext cx="452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7. Retrograde endocannabinoid signaling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6" name="图片 6" descr=""/>
          <p:cNvPicPr/>
          <p:nvPr/>
        </p:nvPicPr>
        <p:blipFill>
          <a:blip r:embed="rId1"/>
          <a:stretch/>
        </p:blipFill>
        <p:spPr>
          <a:xfrm>
            <a:off x="3156120" y="880920"/>
            <a:ext cx="5964120" cy="5843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17T09:07:26Z</dcterms:created>
  <dc:creator>王 雅</dc:creator>
  <dc:description/>
  <dc:language>en-US</dc:language>
  <cp:lastModifiedBy>MC SYSTEM</cp:lastModifiedBy>
  <dcterms:modified xsi:type="dcterms:W3CDTF">2018-08-17T13:39:35Z</dcterms:modified>
  <cp:revision>15</cp:revision>
  <dc:subject/>
  <dc:title>PowerPoint 演示文稿</dc:title>
</cp:coreProperties>
</file>